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7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B38615F-A2BA-4633-8749-62AAC1EE75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784F143-06E2-4ADF-B9BD-099A9CDEDA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B76E55-F88E-4F79-A17C-460271514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5FC684-DE37-4756-BC9B-32EF8BBE7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3C87429-82CD-4B19-9331-0AA94717A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9755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EC8F68-EB6C-492D-89FF-E92BC8090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6CD639A-4186-4F7B-B66B-9FEEE23A64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44D21D1-1572-4BF5-8BE9-445F44B33C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E5CBB3-5EEB-435A-B5C4-D193DDC94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E6C2B8D-9EE9-470C-8F66-42DCA086F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2548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A16A30A-F54E-4C5A-91D6-A0D92068EB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984AD30-26BB-41ED-A1DB-93BA5D6689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58E910A-A214-415E-A380-17D93040D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26BC220-A735-483F-9A87-C167EA421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302A08D-7CE4-47E6-839A-F024796B6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2448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A277648-8150-44E5-A5B5-3E35051CFC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8A4E083-C824-49D0-8250-3211A5D721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BA57DC3-5040-47C3-AC2B-D2D090584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CFC34C0-268B-4EB3-A814-35ABBEDE4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211B83-92C4-486B-B650-25FC54E1A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7693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93E90A9-096E-4984-855A-C8BA5D73F4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3ABAEDD-4646-44FC-9B93-15DD5AEA5C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0AF870-9F80-4F9B-ACCE-349C23D9D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B48C446-2E57-454F-AE4F-2CDE5FDDF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9A39954-D8CD-4A64-ABEC-A23A1CA81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064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B981FB5-1DAD-45F9-BA41-8B25A5D36F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C45C80A-A989-4B27-815B-F82DC6C3F9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65F26B1-8609-4AF3-B029-249CC2F0C2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DECC7CB-61FD-488A-91B5-12C70CE74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D5BD0E8-76E6-4B5F-832D-9462DB56D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5EC6BCF-C1D8-483E-B1B2-95949B174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6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526DA1-217B-4466-95FF-38232FFF9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31B4980-FBFD-48B9-9A26-FB25E9EEE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6A1E556-ECFD-4342-BA9E-AE5066C980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2F97798-C86E-4D37-83E6-A66DB2F5B6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FCF04CCB-7EA6-4FF8-94C6-2AF8F65049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A04D9E0-4840-45C2-8829-EAA15B981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D3B5712-81F4-45FA-95E1-68E7EC003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1D57D43-9A91-4BD4-830F-D5FC54379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64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A3653B4-5800-488A-A747-45E4D4B6F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7F9BCFE-844E-424D-BEC8-15288B538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E782D8A-0DB9-4426-9D92-3470B8FA7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28EAE2A-95D3-44EC-A853-B198C9D86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9948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2959F2D-0BE5-40E6-9E4A-E7B9113C7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5088F67-F926-4A7B-8752-FBC5AFCF7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58A3DA2-BAA5-4D11-8484-FB8B90FD2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101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E551F9-7C27-4F31-94A9-AC81F8997C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D7CE3C1-8B42-4D02-B790-50D1A41D39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5A26D99-B8F8-4CD7-986B-777218B1B6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B667227-3C7F-4F26-A92A-4B92F08FF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8F75FA0-2D84-4B3D-943F-2812C4E54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3BF9C95-D3DA-4671-82B2-C11BAEEDE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2627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3B4985-26C7-4ACD-ACEE-04F15AE517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7D36B87-A82A-4FD0-BEA7-B187416B7E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2108244-D813-4DE5-8B37-9754C2B146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71B0757-6D6C-4EA3-B115-96A912912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A1A78E8-8A46-4C04-912E-9D58113BC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02B8CFA-A1E3-42EB-AE97-5675080C1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274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9C5A791-E716-46B0-8793-7FA3EE1D86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DA39321-F946-4E98-BEAD-64084BBCC6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63B525-E77A-4FA2-B19F-CA9A8D9357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2E415-B42D-4B83-967E-A2EEE970B697}" type="datetimeFigureOut">
              <a:rPr lang="fr-FR" smtClean="0"/>
              <a:t>11/07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FAA3631-710E-4A93-892B-B28705DEDD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0055F06-EFFB-4282-96DC-8285D5830E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DFC4F-16C0-4606-B184-21E8266B11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1734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"/><Relationship Id="rId3" Type="http://schemas.openxmlformats.org/officeDocument/2006/relationships/image" Target="../media/image2.png"/><Relationship Id="rId7" Type="http://schemas.openxmlformats.org/officeDocument/2006/relationships/image" Target="../media/image3.ti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microsoft.com/office/2007/relationships/hdphoto" Target="../media/hdphoto1.wdp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5D45DB9F-B379-40E4-AA84-F2F868F94192}"/>
              </a:ext>
            </a:extLst>
          </p:cNvPr>
          <p:cNvSpPr txBox="1"/>
          <p:nvPr/>
        </p:nvSpPr>
        <p:spPr>
          <a:xfrm>
            <a:off x="1628738" y="211037"/>
            <a:ext cx="2466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Fig. S1</a:t>
            </a:r>
          </a:p>
        </p:txBody>
      </p: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A6F6CC6F-0862-4D06-8DED-8393E0249C85}"/>
              </a:ext>
            </a:extLst>
          </p:cNvPr>
          <p:cNvGrpSpPr/>
          <p:nvPr/>
        </p:nvGrpSpPr>
        <p:grpSpPr>
          <a:xfrm>
            <a:off x="2298312" y="211037"/>
            <a:ext cx="3003260" cy="3217963"/>
            <a:chOff x="4129128" y="1584800"/>
            <a:chExt cx="3003260" cy="3217963"/>
          </a:xfrm>
        </p:grpSpPr>
        <p:grpSp>
          <p:nvGrpSpPr>
            <p:cNvPr id="17" name="Groupe 16">
              <a:extLst>
                <a:ext uri="{FF2B5EF4-FFF2-40B4-BE49-F238E27FC236}">
                  <a16:creationId xmlns:a16="http://schemas.microsoft.com/office/drawing/2014/main" id="{D8C3C586-B95B-4696-96B1-01D2073C0AAD}"/>
                </a:ext>
              </a:extLst>
            </p:cNvPr>
            <p:cNvGrpSpPr/>
            <p:nvPr/>
          </p:nvGrpSpPr>
          <p:grpSpPr>
            <a:xfrm>
              <a:off x="4129128" y="1584800"/>
              <a:ext cx="2201570" cy="3217963"/>
              <a:chOff x="4101696" y="1215468"/>
              <a:chExt cx="2201570" cy="3217963"/>
            </a:xfrm>
          </p:grpSpPr>
          <p:pic>
            <p:nvPicPr>
              <p:cNvPr id="3" name="Image 2">
                <a:extLst>
                  <a:ext uri="{FF2B5EF4-FFF2-40B4-BE49-F238E27FC236}">
                    <a16:creationId xmlns:a16="http://schemas.microsoft.com/office/drawing/2014/main" id="{2887340E-CA1A-416B-996B-998AEDE742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763" t="36472" r="54981" b="40783"/>
              <a:stretch/>
            </p:blipFill>
            <p:spPr>
              <a:xfrm>
                <a:off x="4757930" y="1584800"/>
                <a:ext cx="1545336" cy="284863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cxnSp>
            <p:nvCxnSpPr>
              <p:cNvPr id="6" name="Connecteur droit 5">
                <a:extLst>
                  <a:ext uri="{FF2B5EF4-FFF2-40B4-BE49-F238E27FC236}">
                    <a16:creationId xmlns:a16="http://schemas.microsoft.com/office/drawing/2014/main" id="{8C127267-EA96-4821-B53D-831DE7C7DAFF}"/>
                  </a:ext>
                </a:extLst>
              </p:cNvPr>
              <p:cNvCxnSpPr/>
              <p:nvPr/>
            </p:nvCxnSpPr>
            <p:spPr>
              <a:xfrm flipH="1">
                <a:off x="4553712" y="3675888"/>
                <a:ext cx="17545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Connecteur droit 6">
                <a:extLst>
                  <a:ext uri="{FF2B5EF4-FFF2-40B4-BE49-F238E27FC236}">
                    <a16:creationId xmlns:a16="http://schemas.microsoft.com/office/drawing/2014/main" id="{0E1F3374-3BAD-4E83-A94E-9BF7826D977B}"/>
                  </a:ext>
                </a:extLst>
              </p:cNvPr>
              <p:cNvCxnSpPr/>
              <p:nvPr/>
            </p:nvCxnSpPr>
            <p:spPr>
              <a:xfrm flipH="1">
                <a:off x="4553712" y="3006067"/>
                <a:ext cx="17545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Connecteur droit 7">
                <a:extLst>
                  <a:ext uri="{FF2B5EF4-FFF2-40B4-BE49-F238E27FC236}">
                    <a16:creationId xmlns:a16="http://schemas.microsoft.com/office/drawing/2014/main" id="{C21FB9B0-AB88-4DBD-9295-195708507E0E}"/>
                  </a:ext>
                </a:extLst>
              </p:cNvPr>
              <p:cNvCxnSpPr/>
              <p:nvPr/>
            </p:nvCxnSpPr>
            <p:spPr>
              <a:xfrm flipH="1">
                <a:off x="4553711" y="3268195"/>
                <a:ext cx="17545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ZoneTexte 9">
                <a:extLst>
                  <a:ext uri="{FF2B5EF4-FFF2-40B4-BE49-F238E27FC236}">
                    <a16:creationId xmlns:a16="http://schemas.microsoft.com/office/drawing/2014/main" id="{D786DDF5-0D42-494C-B1CE-493631B318CE}"/>
                  </a:ext>
                </a:extLst>
              </p:cNvPr>
              <p:cNvSpPr txBox="1"/>
              <p:nvPr/>
            </p:nvSpPr>
            <p:spPr>
              <a:xfrm>
                <a:off x="5312664" y="1215468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/>
                  <a:t>1</a:t>
                </a:r>
              </a:p>
            </p:txBody>
          </p:sp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FD3C9ECC-C7B6-4783-8D5A-48A26E6B276E}"/>
                  </a:ext>
                </a:extLst>
              </p:cNvPr>
              <p:cNvSpPr txBox="1"/>
              <p:nvPr/>
            </p:nvSpPr>
            <p:spPr>
              <a:xfrm>
                <a:off x="5821746" y="1215468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/>
                  <a:t>2</a:t>
                </a:r>
              </a:p>
            </p:txBody>
          </p:sp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AF55CC56-A5DB-4E26-834E-5C51506090AD}"/>
                  </a:ext>
                </a:extLst>
              </p:cNvPr>
              <p:cNvSpPr txBox="1"/>
              <p:nvPr/>
            </p:nvSpPr>
            <p:spPr>
              <a:xfrm>
                <a:off x="4545687" y="1215468"/>
                <a:ext cx="8402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b="1" dirty="0"/>
                  <a:t>MW (kb)</a:t>
                </a:r>
              </a:p>
            </p:txBody>
          </p: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44461311-8F92-428A-937E-E7F087112E6C}"/>
                  </a:ext>
                </a:extLst>
              </p:cNvPr>
              <p:cNvSpPr txBox="1"/>
              <p:nvPr/>
            </p:nvSpPr>
            <p:spPr>
              <a:xfrm>
                <a:off x="4101696" y="3102263"/>
                <a:ext cx="4988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/>
                  <a:t>1000</a:t>
                </a:r>
              </a:p>
            </p:txBody>
          </p:sp>
          <p:sp>
            <p:nvSpPr>
              <p:cNvPr id="15" name="ZoneTexte 14">
                <a:extLst>
                  <a:ext uri="{FF2B5EF4-FFF2-40B4-BE49-F238E27FC236}">
                    <a16:creationId xmlns:a16="http://schemas.microsoft.com/office/drawing/2014/main" id="{1C2B9B35-D30C-445A-BECE-59E9318484BB}"/>
                  </a:ext>
                </a:extLst>
              </p:cNvPr>
              <p:cNvSpPr txBox="1"/>
              <p:nvPr/>
            </p:nvSpPr>
            <p:spPr>
              <a:xfrm>
                <a:off x="4101696" y="2834039"/>
                <a:ext cx="4988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/>
                  <a:t>1500</a:t>
                </a:r>
              </a:p>
            </p:txBody>
          </p:sp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CED63814-60F1-42D0-80A2-7CC29852FFAA}"/>
                  </a:ext>
                </a:extLst>
              </p:cNvPr>
              <p:cNvSpPr txBox="1"/>
              <p:nvPr/>
            </p:nvSpPr>
            <p:spPr>
              <a:xfrm>
                <a:off x="4180243" y="3519469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/>
                  <a:t>500</a:t>
                </a:r>
              </a:p>
            </p:txBody>
          </p:sp>
        </p:grp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5D5C4C93-CA21-4575-BFDB-A99228E4B8FC}"/>
                </a:ext>
              </a:extLst>
            </p:cNvPr>
            <p:cNvSpPr txBox="1"/>
            <p:nvPr/>
          </p:nvSpPr>
          <p:spPr>
            <a:xfrm>
              <a:off x="6330698" y="3970728"/>
              <a:ext cx="4953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LC3B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F6F96B4D-1450-4A26-9FD9-87835D5531F2}"/>
                </a:ext>
              </a:extLst>
            </p:cNvPr>
            <p:cNvSpPr txBox="1"/>
            <p:nvPr/>
          </p:nvSpPr>
          <p:spPr>
            <a:xfrm>
              <a:off x="6340440" y="3354736"/>
              <a:ext cx="7919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GFP-LC3B</a:t>
              </a:r>
            </a:p>
          </p:txBody>
        </p:sp>
      </p:grpSp>
      <p:grpSp>
        <p:nvGrpSpPr>
          <p:cNvPr id="22" name="Groupe 21">
            <a:extLst>
              <a:ext uri="{FF2B5EF4-FFF2-40B4-BE49-F238E27FC236}">
                <a16:creationId xmlns:a16="http://schemas.microsoft.com/office/drawing/2014/main" id="{7436490B-4C12-4F45-92F6-8F9B248F389C}"/>
              </a:ext>
            </a:extLst>
          </p:cNvPr>
          <p:cNvGrpSpPr/>
          <p:nvPr/>
        </p:nvGrpSpPr>
        <p:grpSpPr>
          <a:xfrm>
            <a:off x="6017955" y="497051"/>
            <a:ext cx="3477605" cy="2489094"/>
            <a:chOff x="3663859" y="2269134"/>
            <a:chExt cx="3477605" cy="2489094"/>
          </a:xfrm>
        </p:grpSpPr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9A7F87DF-09C5-4D0D-A44A-0BC29931513A}"/>
                </a:ext>
              </a:extLst>
            </p:cNvPr>
            <p:cNvSpPr txBox="1"/>
            <p:nvPr/>
          </p:nvSpPr>
          <p:spPr>
            <a:xfrm rot="16200000">
              <a:off x="3935772" y="3267107"/>
              <a:ext cx="211922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 err="1"/>
                <a:t>Mean</a:t>
              </a:r>
              <a:r>
                <a:rPr lang="fr-FR" sz="1100" b="1" dirty="0"/>
                <a:t> distance </a:t>
              </a:r>
              <a:r>
                <a:rPr lang="fr-FR" sz="1100" b="1" dirty="0" err="1"/>
                <a:t>between</a:t>
              </a:r>
              <a:r>
                <a:rPr lang="fr-FR" sz="1100" b="1" dirty="0"/>
                <a:t> GFP-LC3B </a:t>
              </a:r>
              <a:r>
                <a:rPr lang="fr-FR" sz="1100" b="1" dirty="0" err="1"/>
                <a:t>puncta</a:t>
              </a:r>
              <a:r>
                <a:rPr lang="fr-FR" sz="1100" b="1" dirty="0"/>
                <a:t> and Sir-</a:t>
              </a:r>
              <a:r>
                <a:rPr lang="fr-FR" sz="1100" b="1" dirty="0" err="1"/>
                <a:t>Actin</a:t>
              </a:r>
              <a:r>
                <a:rPr lang="fr-FR" sz="1100" b="1" dirty="0"/>
                <a:t> (µm)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3F8A82C8-5432-4ECC-B642-D85E412D4D9D}"/>
                </a:ext>
              </a:extLst>
            </p:cNvPr>
            <p:cNvSpPr txBox="1"/>
            <p:nvPr/>
          </p:nvSpPr>
          <p:spPr>
            <a:xfrm>
              <a:off x="5697861" y="4388896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-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68AAAC84-CE94-4337-BEFE-D75BF1E73950}"/>
                </a:ext>
              </a:extLst>
            </p:cNvPr>
            <p:cNvSpPr txBox="1"/>
            <p:nvPr/>
          </p:nvSpPr>
          <p:spPr>
            <a:xfrm>
              <a:off x="6516478" y="4388896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+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2288933A-FD9B-4AF1-AA21-05C5AE98C170}"/>
                </a:ext>
              </a:extLst>
            </p:cNvPr>
            <p:cNvSpPr txBox="1"/>
            <p:nvPr/>
          </p:nvSpPr>
          <p:spPr>
            <a:xfrm>
              <a:off x="4608455" y="4435063"/>
              <a:ext cx="7136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/>
                <a:t>VLPs-Env</a:t>
              </a:r>
              <a:endParaRPr lang="fr-FR" sz="1100" b="1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F0B9397A-0173-4B3D-97CA-A1C23B649629}"/>
                </a:ext>
              </a:extLst>
            </p:cNvPr>
            <p:cNvSpPr txBox="1"/>
            <p:nvPr/>
          </p:nvSpPr>
          <p:spPr>
            <a:xfrm flipH="1">
              <a:off x="5512333" y="2269134"/>
              <a:ext cx="152664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HEK GFP-LC3B</a:t>
              </a:r>
              <a:r>
                <a:rPr lang="en-US" baseline="30000" dirty="0"/>
                <a:t>edit</a:t>
              </a:r>
              <a:r>
                <a:rPr lang="fr-FR" sz="1200" b="1" dirty="0"/>
                <a:t>.X4 </a:t>
              </a:r>
            </a:p>
            <a:p>
              <a:pPr algn="ctr"/>
              <a:r>
                <a:rPr lang="fr-FR" sz="1200" b="1" dirty="0"/>
                <a:t>+ AMD3100</a:t>
              </a:r>
            </a:p>
          </p:txBody>
        </p:sp>
        <p:grpSp>
          <p:nvGrpSpPr>
            <p:cNvPr id="28" name="Groupe 27">
              <a:extLst>
                <a:ext uri="{FF2B5EF4-FFF2-40B4-BE49-F238E27FC236}">
                  <a16:creationId xmlns:a16="http://schemas.microsoft.com/office/drawing/2014/main" id="{6C734570-13F9-4F53-B363-D23CA3AD4D24}"/>
                </a:ext>
              </a:extLst>
            </p:cNvPr>
            <p:cNvGrpSpPr/>
            <p:nvPr/>
          </p:nvGrpSpPr>
          <p:grpSpPr>
            <a:xfrm>
              <a:off x="3663859" y="2888663"/>
              <a:ext cx="277000" cy="1451591"/>
              <a:chOff x="664977" y="4069478"/>
              <a:chExt cx="277000" cy="1451591"/>
            </a:xfrm>
          </p:grpSpPr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DA896E56-47D5-4061-A342-7EE4102F2B75}"/>
                  </a:ext>
                </a:extLst>
              </p:cNvPr>
              <p:cNvSpPr txBox="1"/>
              <p:nvPr/>
            </p:nvSpPr>
            <p:spPr>
              <a:xfrm rot="16200000">
                <a:off x="631411" y="4103045"/>
                <a:ext cx="3441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/>
                  <a:t>CT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EB126895-3F11-4CFF-9592-ABF469213621}"/>
                  </a:ext>
                </a:extLst>
              </p:cNvPr>
              <p:cNvSpPr txBox="1"/>
              <p:nvPr/>
            </p:nvSpPr>
            <p:spPr>
              <a:xfrm rot="16200000">
                <a:off x="424527" y="5003619"/>
                <a:ext cx="7579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b="1" dirty="0" err="1"/>
                  <a:t>VLPs-Env</a:t>
                </a:r>
                <a:endParaRPr lang="fr-FR" sz="1200" b="1" dirty="0"/>
              </a:p>
            </p:txBody>
          </p:sp>
        </p:grpSp>
        <p:graphicFrame>
          <p:nvGraphicFramePr>
            <p:cNvPr id="29" name="Objet 28">
              <a:extLst>
                <a:ext uri="{FF2B5EF4-FFF2-40B4-BE49-F238E27FC236}">
                  <a16:creationId xmlns:a16="http://schemas.microsoft.com/office/drawing/2014/main" id="{192F06FC-F811-4241-A54E-149AD1B7C85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10428099"/>
                </p:ext>
              </p:extLst>
            </p:nvPr>
          </p:nvGraphicFramePr>
          <p:xfrm>
            <a:off x="5183397" y="2660905"/>
            <a:ext cx="1958067" cy="19017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5" r:id="rId5" imgW="3191400" imgH="2244960" progId="Prism5.Document">
                    <p:embed/>
                  </p:oleObj>
                </mc:Choice>
                <mc:Fallback>
                  <p:oleObj name="Prism 5" r:id="rId5" imgW="3191400" imgH="2244960" progId="Prism5.Document">
                    <p:embed/>
                    <p:pic>
                      <p:nvPicPr>
                        <p:cNvPr id="3" name="Objet 2">
                          <a:extLst>
                            <a:ext uri="{FF2B5EF4-FFF2-40B4-BE49-F238E27FC236}">
                              <a16:creationId xmlns:a16="http://schemas.microsoft.com/office/drawing/2014/main" id="{34C10196-F6CD-48F0-AD57-E6D1B5377DA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183397" y="2660905"/>
                          <a:ext cx="1958067" cy="19017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0" name="Image 29">
              <a:extLst>
                <a:ext uri="{FF2B5EF4-FFF2-40B4-BE49-F238E27FC236}">
                  <a16:creationId xmlns:a16="http://schemas.microsoft.com/office/drawing/2014/main" id="{BB8CD4DC-35CC-49DA-8249-0A13AD33F66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400" y="2660905"/>
              <a:ext cx="810000" cy="842400"/>
            </a:xfrm>
            <a:prstGeom prst="rect">
              <a:avLst/>
            </a:prstGeom>
          </p:spPr>
        </p:pic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E4F002DE-91CE-470F-A146-A50C2BCC0D7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400" y="3544762"/>
              <a:ext cx="810000" cy="842400"/>
            </a:xfrm>
            <a:prstGeom prst="rect">
              <a:avLst/>
            </a:prstGeom>
          </p:spPr>
        </p:pic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AE8A6690-78E6-42EE-A72B-94CD54886F10}"/>
                </a:ext>
              </a:extLst>
            </p:cNvPr>
            <p:cNvSpPr txBox="1"/>
            <p:nvPr/>
          </p:nvSpPr>
          <p:spPr>
            <a:xfrm>
              <a:off x="6498190" y="2690097"/>
              <a:ext cx="432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/>
                <a:t>ns</a:t>
              </a:r>
            </a:p>
          </p:txBody>
        </p:sp>
      </p:grpSp>
      <p:sp>
        <p:nvSpPr>
          <p:cNvPr id="35" name="ZoneTexte 34">
            <a:extLst>
              <a:ext uri="{FF2B5EF4-FFF2-40B4-BE49-F238E27FC236}">
                <a16:creationId xmlns:a16="http://schemas.microsoft.com/office/drawing/2014/main" id="{29530FFB-393A-49ED-B052-32D47E7187FB}"/>
              </a:ext>
            </a:extLst>
          </p:cNvPr>
          <p:cNvSpPr txBox="1"/>
          <p:nvPr/>
        </p:nvSpPr>
        <p:spPr>
          <a:xfrm>
            <a:off x="6017955" y="212618"/>
            <a:ext cx="2466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Fig. S2</a:t>
            </a:r>
          </a:p>
        </p:txBody>
      </p:sp>
      <p:pic>
        <p:nvPicPr>
          <p:cNvPr id="36" name="Image 35">
            <a:extLst>
              <a:ext uri="{FF2B5EF4-FFF2-40B4-BE49-F238E27FC236}">
                <a16:creationId xmlns:a16="http://schemas.microsoft.com/office/drawing/2014/main" id="{896CD76A-EA22-427F-9BE9-B7EBCB515285}"/>
              </a:ext>
            </a:extLst>
          </p:cNvPr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7955" y="3936209"/>
            <a:ext cx="5163820" cy="2703195"/>
          </a:xfrm>
          <a:prstGeom prst="rect">
            <a:avLst/>
          </a:prstGeom>
          <a:noFill/>
          <a:ln>
            <a:noFill/>
          </a:ln>
        </p:spPr>
      </p:pic>
      <p:sp>
        <p:nvSpPr>
          <p:cNvPr id="37" name="ZoneTexte 36">
            <a:extLst>
              <a:ext uri="{FF2B5EF4-FFF2-40B4-BE49-F238E27FC236}">
                <a16:creationId xmlns:a16="http://schemas.microsoft.com/office/drawing/2014/main" id="{B7F84D88-5705-4677-B247-01EFA26468B9}"/>
              </a:ext>
            </a:extLst>
          </p:cNvPr>
          <p:cNvSpPr txBox="1"/>
          <p:nvPr/>
        </p:nvSpPr>
        <p:spPr>
          <a:xfrm>
            <a:off x="6017955" y="3443607"/>
            <a:ext cx="2466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22634028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3</Words>
  <Application>Microsoft Office PowerPoint</Application>
  <PresentationFormat>Grand écran</PresentationFormat>
  <Paragraphs>20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5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ucile Espert</dc:creator>
  <cp:lastModifiedBy>Lucile Espert</cp:lastModifiedBy>
  <cp:revision>2</cp:revision>
  <dcterms:created xsi:type="dcterms:W3CDTF">2023-07-11T15:16:49Z</dcterms:created>
  <dcterms:modified xsi:type="dcterms:W3CDTF">2023-07-11T15:42:13Z</dcterms:modified>
</cp:coreProperties>
</file>